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6" r:id="rId3"/>
    <p:sldId id="25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90"/>
  </p:normalViewPr>
  <p:slideViewPr>
    <p:cSldViewPr snapToGrid="0" snapToObjects="1">
      <p:cViewPr varScale="1">
        <p:scale>
          <a:sx n="48" d="100"/>
          <a:sy n="48" d="100"/>
        </p:scale>
        <p:origin x="41" y="8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D77DE8-E454-2240-8EED-CF771D2FFF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C2F062D-6DF2-0F46-A9A8-02449651FCB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E91573-98FE-3C49-8196-1D3B572E8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30C4D-ECB4-D949-8F26-2E50AF93CA2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ACCD3A-6A89-BD4C-B34F-3DC01A42C0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F0A901-49A5-464A-B7E1-7FF887950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E131B-D66C-7A44-9C30-68AA1A9A67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149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522ECC-10CF-D548-A251-4186EBE59D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B24E6B-7361-6342-921A-969A3508BF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3F88E1-7DFB-1A45-BAE1-FC3CCC91BB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30C4D-ECB4-D949-8F26-2E50AF93CA2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600E75-9A62-0D45-9034-832501335A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FAC7FA-36E1-E14C-8C9B-5B6B761075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E131B-D66C-7A44-9C30-68AA1A9A67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69184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F85A3EF-CAE1-EF4D-9020-B6576FBA7A7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73F884-5BE2-7248-8E02-BB5574F84D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0923FE-56C9-EB4A-9A77-312C59118B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30C4D-ECB4-D949-8F26-2E50AF93CA2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B9C4D9-A233-B54C-AA9C-0822BD38EF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A1D9E2-F439-D440-AB02-DE0406CC9A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E131B-D66C-7A44-9C30-68AA1A9A67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85682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F9AC1A-9CB1-274A-98A4-F41BF4DF00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A723DD-59A0-7546-840A-A412B857CF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2C3FC8-0059-B64B-9B82-2306C4B287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30C4D-ECB4-D949-8F26-2E50AF93CA2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5BA7B6-590F-274F-AD1A-F47D7AF36D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98C299-E35B-AA4A-B635-B728308E5A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E131B-D66C-7A44-9C30-68AA1A9A67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8905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1D8BE8-7908-CC4E-B705-0F2774A0AB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321624-A504-D84B-848F-F0372D96CC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AC99E5-3AD1-324E-B65D-AA4E6DCC8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30C4D-ECB4-D949-8F26-2E50AF93CA2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C67180-7340-3B47-B89E-1F7ED2892C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017A66-FF29-5D43-B665-7CF44CF8A6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E131B-D66C-7A44-9C30-68AA1A9A67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445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CC832F-0206-E74D-95C1-DD45E4C17A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A999D9-8831-664B-A6B8-DB12463DC3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64D0711-E4F6-AB4C-BB73-CF0E2F4BAB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DEF5A9-D015-634B-821F-D910CD01DB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30C4D-ECB4-D949-8F26-2E50AF93CA2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9DFDE4-9F4F-BC4F-88C1-D2961EB20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7558EE-DA66-9B40-A8D4-428D892212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E131B-D66C-7A44-9C30-68AA1A9A67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474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8DF531-2240-4842-B1CC-5C60DF1A29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3A3D64-DDA3-9E47-ADBC-822BD07167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1A0DA5-67C3-F646-A50B-46742B0E9B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F757635-F549-5B40-B844-C1A1D66A92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7F85751-A94A-2947-A25F-D8FD44336E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9256DB2-AC39-2F47-ACD6-26AD6D20F2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30C4D-ECB4-D949-8F26-2E50AF93CA2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87E7005-EC66-FF4E-B44C-CA4DBF5A36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EF32833-3C3C-034D-9507-B3E20FAE20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E131B-D66C-7A44-9C30-68AA1A9A67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267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A55039-8775-FA47-9A9F-7D5AB3927C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5629382-D251-6A49-91D9-C77454F326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30C4D-ECB4-D949-8F26-2E50AF93CA2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CB97A57-19F5-3047-8136-67A8696EB5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0571FE7-882B-974E-9A55-43540224B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E131B-D66C-7A44-9C30-68AA1A9A67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01680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FE2B584-E6BD-4E4B-9F8C-F83D9E58EC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30C4D-ECB4-D949-8F26-2E50AF93CA2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1F854BE-BC50-844C-AAC9-775B3B27E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4BB35BC-8AA7-424A-B6D4-9010F661D8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E131B-D66C-7A44-9C30-68AA1A9A67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8537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B65E8D-15C8-EA47-9A41-B55CAAA65C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002058-4D31-1640-A9F4-7DFF7F43CD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078BA2-169A-BF44-BB1C-5997D71ED8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236460-DC7E-2E46-A10F-B5E977E2E4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30C4D-ECB4-D949-8F26-2E50AF93CA2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8DEC80-261B-C64D-A689-5FC0722FCD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681936-42DD-0D40-9722-CE2D5AA267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E131B-D66C-7A44-9C30-68AA1A9A67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315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9967F3-F1D9-6347-8829-040131B5C3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24BFD94-A2C6-0346-93F0-08A56C0754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F7013E-7441-D244-8A57-7603894DCB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38C661-6270-B04E-8B68-E86062142F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30C4D-ECB4-D949-8F26-2E50AF93CA2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F84AA4-F7E1-9144-AB16-1949A5DC8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13737F-471D-A54B-B5CD-151CF669E4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E131B-D66C-7A44-9C30-68AA1A9A67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162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57480A8-CCF5-644D-B266-79CF7FB490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83257E-2A46-CF40-AF3C-43C57A9E07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C709F9-1FB3-0A45-8426-BC835CBB1F0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930C4D-ECB4-D949-8F26-2E50AF93CA2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0E5485-CC95-1E48-B482-054E0B51AB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60A3F0-E14D-3B4A-BFF5-623E4B54DD4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AE131B-D66C-7A44-9C30-68AA1A9A67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7596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7" Type="http://schemas.microsoft.com/office/2007/relationships/hdphoto" Target="../media/hdphoto2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microsoft.com/office/2007/relationships/hdphoto" Target="../media/hdphoto1.wdp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10023A7-3ADF-E14B-A6C9-010D9817E0C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" t="7204" r="423" b="71570"/>
          <a:stretch/>
        </p:blipFill>
        <p:spPr>
          <a:xfrm>
            <a:off x="707136" y="1789044"/>
            <a:ext cx="9191049" cy="132478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D4B0236-E435-3347-8983-8F59685C7EA1}"/>
              </a:ext>
            </a:extLst>
          </p:cNvPr>
          <p:cNvSpPr txBox="1"/>
          <p:nvPr/>
        </p:nvSpPr>
        <p:spPr>
          <a:xfrm>
            <a:off x="10192512" y="2082102"/>
            <a:ext cx="1292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IV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CB161F1-B6AB-6D43-8593-F383B1824910}"/>
              </a:ext>
            </a:extLst>
          </p:cNvPr>
          <p:cNvSpPr txBox="1"/>
          <p:nvPr/>
        </p:nvSpPr>
        <p:spPr>
          <a:xfrm>
            <a:off x="890016" y="3459348"/>
            <a:ext cx="9558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adder      Tam 13      Tam 14       Tam 15      Tam 16     Tam 18        Tam 19      Tam 21     Tam 20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C865577-C8F1-D140-8545-5A9E4FACB5F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2996" b="19712"/>
          <a:stretch/>
        </p:blipFill>
        <p:spPr>
          <a:xfrm>
            <a:off x="798575" y="4418043"/>
            <a:ext cx="9191048" cy="132478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FF28D4F-8597-DF44-95E8-8B11B2FA1086}"/>
              </a:ext>
            </a:extLst>
          </p:cNvPr>
          <p:cNvSpPr txBox="1"/>
          <p:nvPr/>
        </p:nvSpPr>
        <p:spPr>
          <a:xfrm>
            <a:off x="10192512" y="4757267"/>
            <a:ext cx="11338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eta Tubulin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9C440C5-2FD3-4F76-985D-1D4A77363B68}"/>
              </a:ext>
            </a:extLst>
          </p:cNvPr>
          <p:cNvSpPr txBox="1"/>
          <p:nvPr/>
        </p:nvSpPr>
        <p:spPr>
          <a:xfrm>
            <a:off x="3058879" y="965769"/>
            <a:ext cx="12268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GIV KO</a:t>
            </a:r>
            <a:endParaRPr lang="en-GB" sz="28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C4762A4-DDAC-4F9D-B455-8A584C844926}"/>
              </a:ext>
            </a:extLst>
          </p:cNvPr>
          <p:cNvSpPr txBox="1"/>
          <p:nvPr/>
        </p:nvSpPr>
        <p:spPr>
          <a:xfrm>
            <a:off x="7501420" y="890562"/>
            <a:ext cx="68800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WT</a:t>
            </a:r>
            <a:endParaRPr lang="en-GB" sz="2800" b="1" dirty="0"/>
          </a:p>
        </p:txBody>
      </p:sp>
      <p:sp>
        <p:nvSpPr>
          <p:cNvPr id="6" name="Left Brace 5">
            <a:extLst>
              <a:ext uri="{FF2B5EF4-FFF2-40B4-BE49-F238E27FC236}">
                <a16:creationId xmlns:a16="http://schemas.microsoft.com/office/drawing/2014/main" id="{D447DAA2-BA19-4981-9FFB-C016E0B0FC4D}"/>
              </a:ext>
            </a:extLst>
          </p:cNvPr>
          <p:cNvSpPr/>
          <p:nvPr/>
        </p:nvSpPr>
        <p:spPr>
          <a:xfrm rot="5400000">
            <a:off x="7706277" y="-470091"/>
            <a:ext cx="278296" cy="4105522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Left Brace 10">
            <a:extLst>
              <a:ext uri="{FF2B5EF4-FFF2-40B4-BE49-F238E27FC236}">
                <a16:creationId xmlns:a16="http://schemas.microsoft.com/office/drawing/2014/main" id="{D010F35F-131B-4290-8A11-3238DCAA3282}"/>
              </a:ext>
            </a:extLst>
          </p:cNvPr>
          <p:cNvSpPr/>
          <p:nvPr/>
        </p:nvSpPr>
        <p:spPr>
          <a:xfrm rot="5400000">
            <a:off x="3533168" y="-477823"/>
            <a:ext cx="278296" cy="4105522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37912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white, cabinet, close&#10;&#10;Description automatically generated">
            <a:extLst>
              <a:ext uri="{FF2B5EF4-FFF2-40B4-BE49-F238E27FC236}">
                <a16:creationId xmlns:a16="http://schemas.microsoft.com/office/drawing/2014/main" id="{B7123242-0319-E44E-9FBB-96808C60DA3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265" r="3822" b="71520"/>
          <a:stretch/>
        </p:blipFill>
        <p:spPr>
          <a:xfrm>
            <a:off x="304800" y="512064"/>
            <a:ext cx="9204960" cy="1475232"/>
          </a:xfrm>
          <a:prstGeom prst="rect">
            <a:avLst/>
          </a:prstGeom>
        </p:spPr>
      </p:pic>
      <p:pic>
        <p:nvPicPr>
          <p:cNvPr id="6" name="Picture 5" descr="A picture containing white, cabinet, close&#10;&#10;Description automatically generated">
            <a:extLst>
              <a:ext uri="{FF2B5EF4-FFF2-40B4-BE49-F238E27FC236}">
                <a16:creationId xmlns:a16="http://schemas.microsoft.com/office/drawing/2014/main" id="{EA071EDC-3E07-084C-B4A4-65416C00586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2165" r="2930" b="25619"/>
          <a:stretch/>
        </p:blipFill>
        <p:spPr>
          <a:xfrm>
            <a:off x="304800" y="3157728"/>
            <a:ext cx="9290304" cy="147523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FA5E54A-C4BA-E04E-B937-E10AEB84853E}"/>
              </a:ext>
            </a:extLst>
          </p:cNvPr>
          <p:cNvSpPr txBox="1"/>
          <p:nvPr/>
        </p:nvSpPr>
        <p:spPr>
          <a:xfrm>
            <a:off x="9875520" y="670560"/>
            <a:ext cx="1292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IV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DC71765-AAF6-7048-8BB1-78C1A93250F0}"/>
              </a:ext>
            </a:extLst>
          </p:cNvPr>
          <p:cNvSpPr txBox="1"/>
          <p:nvPr/>
        </p:nvSpPr>
        <p:spPr>
          <a:xfrm>
            <a:off x="9851136" y="3535680"/>
            <a:ext cx="11338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eta Tubulin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C6EC7D5-C7A7-8446-80DE-017DC9433D25}"/>
              </a:ext>
            </a:extLst>
          </p:cNvPr>
          <p:cNvSpPr txBox="1"/>
          <p:nvPr/>
        </p:nvSpPr>
        <p:spPr>
          <a:xfrm>
            <a:off x="548640" y="2255520"/>
            <a:ext cx="9558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adder      Tam 13      Tam 14       Tam 15      Tam 16     Tam 18        Tam 19      Tam 21     Tam 20 </a:t>
            </a:r>
          </a:p>
        </p:txBody>
      </p:sp>
    </p:spTree>
    <p:extLst>
      <p:ext uri="{BB962C8B-B14F-4D97-AF65-F5344CB8AC3E}">
        <p14:creationId xmlns:p14="http://schemas.microsoft.com/office/powerpoint/2010/main" val="39823358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white, cabinet, close&#10;&#10;Description automatically generated">
            <a:extLst>
              <a:ext uri="{FF2B5EF4-FFF2-40B4-BE49-F238E27FC236}">
                <a16:creationId xmlns:a16="http://schemas.microsoft.com/office/drawing/2014/main" id="{B651D4EB-2185-4942-A4DC-A2D7296BB4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6991" y="583454"/>
            <a:ext cx="5584135" cy="3874456"/>
          </a:xfrm>
          <a:prstGeom prst="rect">
            <a:avLst/>
          </a:prstGeom>
        </p:spPr>
      </p:pic>
      <p:pic>
        <p:nvPicPr>
          <p:cNvPr id="4" name="Picture 3" descr="A picture containing text, indoor&#10;&#10;Description automatically generated">
            <a:extLst>
              <a:ext uri="{FF2B5EF4-FFF2-40B4-BE49-F238E27FC236}">
                <a16:creationId xmlns:a16="http://schemas.microsoft.com/office/drawing/2014/main" id="{A9158420-0391-9F4F-96DC-582B8163FBF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178" t="45679" r="64947" b="27408"/>
          <a:stretch/>
        </p:blipFill>
        <p:spPr>
          <a:xfrm rot="16200000" flipV="1">
            <a:off x="6981652" y="36471"/>
            <a:ext cx="3874455" cy="4968422"/>
          </a:xfrm>
          <a:prstGeom prst="rect">
            <a:avLst/>
          </a:prstGeom>
        </p:spPr>
      </p:pic>
      <p:pic>
        <p:nvPicPr>
          <p:cNvPr id="5" name="Picture 4" descr="A picture containing white, cabinet, close&#10;&#10;Description automatically generated">
            <a:extLst>
              <a:ext uri="{FF2B5EF4-FFF2-40B4-BE49-F238E27FC236}">
                <a16:creationId xmlns:a16="http://schemas.microsoft.com/office/drawing/2014/main" id="{E60D50E0-CD68-4E4F-8F15-2AAFB503181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11026" t="33863" r="2729" b="42290"/>
          <a:stretch/>
        </p:blipFill>
        <p:spPr>
          <a:xfrm>
            <a:off x="2704353" y="5812583"/>
            <a:ext cx="4816023" cy="923925"/>
          </a:xfrm>
          <a:prstGeom prst="rect">
            <a:avLst/>
          </a:prstGeom>
        </p:spPr>
      </p:pic>
      <p:pic>
        <p:nvPicPr>
          <p:cNvPr id="7" name="Picture 6" descr="A picture containing white, cabinet, close&#10;&#10;Description automatically generated">
            <a:extLst>
              <a:ext uri="{FF2B5EF4-FFF2-40B4-BE49-F238E27FC236}">
                <a16:creationId xmlns:a16="http://schemas.microsoft.com/office/drawing/2014/main" id="{B7548A90-EBD4-4F78-BCFF-23C13A39043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11026" t="6820" r="2729" b="71422"/>
          <a:stretch/>
        </p:blipFill>
        <p:spPr>
          <a:xfrm>
            <a:off x="2704353" y="4819650"/>
            <a:ext cx="4816023" cy="84296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FD8DC91-CB88-4A4A-997A-A9F32C93F50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11793" t="7204" r="2971" b="71570"/>
          <a:stretch/>
        </p:blipFill>
        <p:spPr>
          <a:xfrm>
            <a:off x="2704353" y="3952875"/>
            <a:ext cx="4816023" cy="8009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87176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43</Words>
  <Application>Microsoft Office PowerPoint</Application>
  <PresentationFormat>Widescreen</PresentationFormat>
  <Paragraphs>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nessa Castillo</dc:creator>
  <cp:lastModifiedBy>Pradipta Ghosh</cp:lastModifiedBy>
  <cp:revision>5</cp:revision>
  <dcterms:created xsi:type="dcterms:W3CDTF">2020-11-06T18:27:42Z</dcterms:created>
  <dcterms:modified xsi:type="dcterms:W3CDTF">2021-04-27T14:59:42Z</dcterms:modified>
</cp:coreProperties>
</file>